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1975"/>
  </p:normalViewPr>
  <p:slideViewPr>
    <p:cSldViewPr snapToGrid="0" snapToObjects="1">
      <p:cViewPr>
        <p:scale>
          <a:sx n="59" d="100"/>
          <a:sy n="59" d="100"/>
        </p:scale>
        <p:origin x="2064" y="8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115769-6372-9148-A6E3-38EADF693D11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A1C95A-A333-C94B-A4C9-975EE770D95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35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smtClean="0"/>
              <a:t>Additional file 2</a:t>
            </a:r>
            <a:r>
              <a:rPr lang="en-US" b="1" dirty="0" smtClean="0"/>
              <a:t>: </a:t>
            </a:r>
            <a:r>
              <a:rPr lang="en-US" dirty="0" smtClean="0"/>
              <a:t>Multiple comparison</a:t>
            </a:r>
            <a:r>
              <a:rPr lang="en-US" i="1" dirty="0" smtClean="0"/>
              <a:t> </a:t>
            </a:r>
            <a:r>
              <a:rPr lang="en-US" dirty="0" smtClean="0"/>
              <a:t>analyses of the percentage of high immunostaining for PACE4-FL and PACE4-altCT among benign versus malignant nodules. </a:t>
            </a:r>
            <a:r>
              <a:rPr lang="en-US" i="1" dirty="0" smtClean="0"/>
              <a:t>p</a:t>
            </a:r>
            <a:r>
              <a:rPr lang="en-US" dirty="0" smtClean="0"/>
              <a:t> values were calculated with the Fischer exact test, and adjusted with the false discovery rate (FDR) correction.</a:t>
            </a:r>
            <a:endParaRPr lang="fr-FR" dirty="0" smtClean="0"/>
          </a:p>
          <a:p>
            <a:r>
              <a:rPr lang="en-US" dirty="0" smtClean="0"/>
              <a:t>* Comparisons for which exact Fisher test could not be computed.</a:t>
            </a:r>
            <a:endParaRPr lang="fr-FR" dirty="0" smtClean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A1C95A-A333-C94B-A4C9-975EE770D95D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22072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9905-70EC-3247-88E3-7CE5D75F1BF8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C8D61-A6C4-CF4D-B787-5E68A7651E1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4940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9905-70EC-3247-88E3-7CE5D75F1BF8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C8D61-A6C4-CF4D-B787-5E68A7651E1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818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9905-70EC-3247-88E3-7CE5D75F1BF8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C8D61-A6C4-CF4D-B787-5E68A7651E1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066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9905-70EC-3247-88E3-7CE5D75F1BF8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C8D61-A6C4-CF4D-B787-5E68A7651E1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4882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9905-70EC-3247-88E3-7CE5D75F1BF8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C8D61-A6C4-CF4D-B787-5E68A7651E1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1520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9905-70EC-3247-88E3-7CE5D75F1BF8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C8D61-A6C4-CF4D-B787-5E68A7651E1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60691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9905-70EC-3247-88E3-7CE5D75F1BF8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C8D61-A6C4-CF4D-B787-5E68A7651E1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6076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9905-70EC-3247-88E3-7CE5D75F1BF8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C8D61-A6C4-CF4D-B787-5E68A7651E1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8334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9905-70EC-3247-88E3-7CE5D75F1BF8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C8D61-A6C4-CF4D-B787-5E68A7651E1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9568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9905-70EC-3247-88E3-7CE5D75F1BF8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C8D61-A6C4-CF4D-B787-5E68A7651E1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1408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69905-70EC-3247-88E3-7CE5D75F1BF8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C8D61-A6C4-CF4D-B787-5E68A7651E1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0508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269905-70EC-3247-88E3-7CE5D75F1BF8}" type="datetimeFigureOut">
              <a:rPr lang="fr-FR" smtClean="0"/>
              <a:t>06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EC8D61-A6C4-CF4D-B787-5E68A7651E1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6415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5900964"/>
              </p:ext>
            </p:extLst>
          </p:nvPr>
        </p:nvGraphicFramePr>
        <p:xfrm>
          <a:off x="2611659" y="940480"/>
          <a:ext cx="6921063" cy="497520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127535"/>
                <a:gridCol w="2275646"/>
                <a:gridCol w="632585"/>
                <a:gridCol w="632585"/>
                <a:gridCol w="632585"/>
                <a:gridCol w="620127"/>
              </a:tblGrid>
              <a:tr h="123751">
                <a:tc rowSpan="2"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500">
                          <a:effectLst/>
                        </a:rPr>
                        <a:t>DIAGNOSIS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ctr"/>
                </a:tc>
                <a:tc rowSpan="2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ACE4-FL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PACE4-al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396418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Raw p-values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FDR corrected p-values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Raw p-values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>
                          <a:effectLst/>
                        </a:rPr>
                        <a:t>FDR corrected p-values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ctr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500">
                          <a:effectLst/>
                        </a:rPr>
                        <a:t>ADENOMATOUS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500">
                          <a:effectLst/>
                        </a:rPr>
                        <a:t>C</a:t>
                      </a:r>
                      <a:r>
                        <a:rPr lang="fr-CA" sz="500">
                          <a:effectLst/>
                        </a:rPr>
                        <a:t>OLLOID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ADENOMATOUS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ADE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ADENOMATOUS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167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482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524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ADENOMATOUS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HYPERPLASTIC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ADENOMATOUS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LYMPHOCYTIC THYROIDITIS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ADENOMATOUS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MEDULLARY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286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531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429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ADENOMATOUS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CLASSICAL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008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069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ADENOMATOUS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FOLLICULAR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COLLOID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ADE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5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COLLOID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429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639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143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COLLOID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HYPERPLASTIC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467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COLLOID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LYMPHOCYTIC THYROIDITIS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COLLOID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MEDULLARY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333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COLLOID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CLASSICAL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048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178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COLLOID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FOLLICULAR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ADE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222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525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293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ADE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HYPERPLASTIC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467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639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ADE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LYMPHOCYTIC THYROIDITIS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ADE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MEDULLARY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417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639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444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ADE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CLASSICAL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015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098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576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ADE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FOLLICULAR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HYPERPLASTIC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035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178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565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LYMPHOCYTIC THYROIDITIS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429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639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MEDULLARY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CLASSICAL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444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639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206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FOLLICULAR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FOLLICULAR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167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482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524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HYPERPLASTIC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LYMPHOCYTIC THYROIDITIS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HYPERPLASTIC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MEDULLARY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2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52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467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HYPERPLASTIC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CLASSICAL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001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026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565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HYPERPLASTIC NODULE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FOLLICULAR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LYMPHOCYTIC THYROIDITIS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MEDULLARY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LYMPHOCYTIC THYROIDITIS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CLASSICAL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048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178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LYMPHOCYTIC THYROIDITIS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FOLLICULAR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 -*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MEDULLARY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CLASSICAL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286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531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143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MEDULLARY CARCINOMA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FOLLICULAR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286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531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429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  <a:tr h="12375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>
                          <a:effectLst/>
                        </a:rPr>
                        <a:t>PAPILLARY CARCINOMA, CLASSICAL VARIANT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CA" sz="500" dirty="0">
                          <a:effectLst/>
                        </a:rPr>
                        <a:t>PAPILLARY CARCINOMA, FOLLICULAR VARIANT</a:t>
                      </a:r>
                      <a:endParaRPr lang="fr-FR" sz="700" dirty="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 anchor="b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008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0,069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>
                          <a:effectLst/>
                        </a:rPr>
                        <a:t>1,000</a:t>
                      </a:r>
                      <a:endParaRPr lang="fr-FR" sz="70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CA" sz="600" dirty="0">
                          <a:effectLst/>
                        </a:rPr>
                        <a:t>1,000</a:t>
                      </a:r>
                      <a:endParaRPr lang="fr-FR" sz="700" dirty="0">
                        <a:effectLst/>
                        <a:latin typeface="Times New Roman" charset="0"/>
                        <a:ea typeface="Calibri" charset="0"/>
                      </a:endParaRPr>
                    </a:p>
                  </a:txBody>
                  <a:tcPr marL="25254" marR="25254" marT="0" marB="0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582068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392</Words>
  <Application>Microsoft Macintosh PowerPoint</Application>
  <PresentationFormat>Grand écran</PresentationFormat>
  <Paragraphs>226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aurent Fradet</dc:creator>
  <cp:lastModifiedBy>Laurent Fradet</cp:lastModifiedBy>
  <cp:revision>6</cp:revision>
  <dcterms:created xsi:type="dcterms:W3CDTF">2018-03-25T16:52:00Z</dcterms:created>
  <dcterms:modified xsi:type="dcterms:W3CDTF">2018-04-06T21:32:42Z</dcterms:modified>
</cp:coreProperties>
</file>